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61" autoAdjust="0"/>
    <p:restoredTop sz="94660"/>
  </p:normalViewPr>
  <p:slideViewPr>
    <p:cSldViewPr snapToGrid="0">
      <p:cViewPr varScale="1">
        <p:scale>
          <a:sx n="45" d="100"/>
          <a:sy n="45" d="100"/>
        </p:scale>
        <p:origin x="24" y="92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9ABD7E-8952-489B-999B-8F67FAD28DFF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B4C9DC-6504-4FDB-9AD8-1C1152ACC4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8707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9ABD7E-8952-489B-999B-8F67FAD28DFF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B4C9DC-6504-4FDB-9AD8-1C1152ACC4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82834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9ABD7E-8952-489B-999B-8F67FAD28DFF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B4C9DC-6504-4FDB-9AD8-1C1152ACC4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40934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9ABD7E-8952-489B-999B-8F67FAD28DFF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B4C9DC-6504-4FDB-9AD8-1C1152ACC4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47118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9ABD7E-8952-489B-999B-8F67FAD28DFF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B4C9DC-6504-4FDB-9AD8-1C1152ACC4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44841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9ABD7E-8952-489B-999B-8F67FAD28DFF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B4C9DC-6504-4FDB-9AD8-1C1152ACC4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86567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9ABD7E-8952-489B-999B-8F67FAD28DFF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B4C9DC-6504-4FDB-9AD8-1C1152ACC4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89767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9ABD7E-8952-489B-999B-8F67FAD28DFF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B4C9DC-6504-4FDB-9AD8-1C1152ACC4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51445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9ABD7E-8952-489B-999B-8F67FAD28DFF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B4C9DC-6504-4FDB-9AD8-1C1152ACC4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80601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9ABD7E-8952-489B-999B-8F67FAD28DFF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B4C9DC-6504-4FDB-9AD8-1C1152ACC4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37127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9ABD7E-8952-489B-999B-8F67FAD28DFF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B4C9DC-6504-4FDB-9AD8-1C1152ACC4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20371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9ABD7E-8952-489B-999B-8F67FAD28DFF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FB4C9DC-6504-4FDB-9AD8-1C1152ACC4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42924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34715" y="555574"/>
            <a:ext cx="10034337" cy="5283752"/>
          </a:xfrm>
          <a:prstGeom prst="rect">
            <a:avLst/>
          </a:prstGeom>
          <a:noFill/>
          <a:ln>
            <a:noFill/>
          </a:ln>
        </p:spPr>
      </p:pic>
      <p:sp>
        <p:nvSpPr>
          <p:cNvPr id="2" name="Rectangle 1"/>
          <p:cNvSpPr>
            <a:spLocks noChangeArrowheads="1"/>
          </p:cNvSpPr>
          <p:nvPr/>
        </p:nvSpPr>
        <p:spPr bwMode="auto">
          <a:xfrm>
            <a:off x="1557866" y="5839326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vi-VN" altLang="en-US" sz="12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Figure </a:t>
            </a:r>
            <a:r>
              <a:rPr kumimoji="0" lang="en-US" altLang="en-US" sz="12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S30</a:t>
            </a:r>
            <a:r>
              <a:rPr kumimoji="0" lang="vi-VN" altLang="en-US" sz="12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. </a:t>
            </a:r>
            <a:r>
              <a:rPr kumimoji="0" lang="vi-VN" altLang="en-US" sz="12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Correlation between β-</a:t>
            </a:r>
            <a:r>
              <a:rPr kumimoji="0" lang="vi-VN" altLang="en-US" sz="1200" b="0" i="0" u="sng" strike="noStrike" cap="none" normalizeH="0" baseline="0" smtClean="0">
                <a:ln>
                  <a:noFill/>
                </a:ln>
                <a:solidFill>
                  <a:srgbClr val="008080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haematin</a:t>
            </a:r>
            <a:r>
              <a:rPr kumimoji="0" lang="vi-VN" altLang="en-US" sz="12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 inhibition activity 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(BIHA</a:t>
            </a:r>
            <a:r>
              <a:rPr kumimoji="0" lang="en-US" altLang="en-US" sz="1200" b="0" i="0" u="none" strike="noStrike" cap="none" normalizeH="0" baseline="-3000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50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, µM)</a:t>
            </a:r>
            <a:r>
              <a:rPr kumimoji="0" lang="vi-VN" altLang="en-US" sz="12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 and </a:t>
            </a:r>
            <a:r>
              <a:rPr kumimoji="0" lang="vi-VN" altLang="en-US" sz="1200" b="0" i="0" u="sng" strike="noStrike" cap="none" normalizeH="0" baseline="0" smtClean="0">
                <a:ln>
                  <a:noFill/>
                </a:ln>
                <a:solidFill>
                  <a:srgbClr val="008080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anti-malarial</a:t>
            </a:r>
            <a:r>
              <a:rPr kumimoji="0" lang="vi-VN" altLang="en-US" sz="12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 activity 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(IC</a:t>
            </a:r>
            <a:r>
              <a:rPr kumimoji="0" lang="en-US" altLang="en-US" sz="1200" b="0" i="0" u="none" strike="noStrike" cap="none" normalizeH="0" baseline="-3000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50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­, µM)</a:t>
            </a:r>
            <a:r>
              <a:rPr kumimoji="0" lang="vi-VN" altLang="en-US" sz="12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 for acridines against resistant strain BRE1</a:t>
            </a: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rPr>
              <a:t> 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216684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7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MS Mincho</vt:lpstr>
      <vt:lpstr>Times New Roman</vt:lpstr>
      <vt:lpstr>Office Theme</vt:lpstr>
      <vt:lpstr>PowerPoint Presentation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goc Nguyen</dc:creator>
  <cp:lastModifiedBy>Ngoc Nguyen</cp:lastModifiedBy>
  <cp:revision>2</cp:revision>
  <dcterms:created xsi:type="dcterms:W3CDTF">2020-07-03T16:18:33Z</dcterms:created>
  <dcterms:modified xsi:type="dcterms:W3CDTF">2020-08-04T16:37:58Z</dcterms:modified>
</cp:coreProperties>
</file>